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7199313" cy="7559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0" autoAdjust="0"/>
    <p:restoredTop sz="94660"/>
  </p:normalViewPr>
  <p:slideViewPr>
    <p:cSldViewPr snapToGrid="0">
      <p:cViewPr varScale="1">
        <p:scale>
          <a:sx n="60" d="100"/>
          <a:sy n="60" d="100"/>
        </p:scale>
        <p:origin x="1000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949" y="1237197"/>
            <a:ext cx="6119416" cy="2631887"/>
          </a:xfrm>
        </p:spPr>
        <p:txBody>
          <a:bodyPr anchor="b"/>
          <a:lstStyle>
            <a:lvl1pPr algn="ctr">
              <a:defRPr sz="4724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9914" y="3970580"/>
            <a:ext cx="5399485" cy="1825171"/>
          </a:xfrm>
        </p:spPr>
        <p:txBody>
          <a:bodyPr/>
          <a:lstStyle>
            <a:lvl1pPr marL="0" indent="0" algn="ctr">
              <a:buNone/>
              <a:defRPr sz="1890"/>
            </a:lvl1pPr>
            <a:lvl2pPr marL="359954" indent="0" algn="ctr">
              <a:buNone/>
              <a:defRPr sz="1575"/>
            </a:lvl2pPr>
            <a:lvl3pPr marL="719907" indent="0" algn="ctr">
              <a:buNone/>
              <a:defRPr sz="1417"/>
            </a:lvl3pPr>
            <a:lvl4pPr marL="1079861" indent="0" algn="ctr">
              <a:buNone/>
              <a:defRPr sz="1260"/>
            </a:lvl4pPr>
            <a:lvl5pPr marL="1439814" indent="0" algn="ctr">
              <a:buNone/>
              <a:defRPr sz="1260"/>
            </a:lvl5pPr>
            <a:lvl6pPr marL="1799768" indent="0" algn="ctr">
              <a:buNone/>
              <a:defRPr sz="1260"/>
            </a:lvl6pPr>
            <a:lvl7pPr marL="2159721" indent="0" algn="ctr">
              <a:buNone/>
              <a:defRPr sz="1260"/>
            </a:lvl7pPr>
            <a:lvl8pPr marL="2519675" indent="0" algn="ctr">
              <a:buNone/>
              <a:defRPr sz="1260"/>
            </a:lvl8pPr>
            <a:lvl9pPr marL="2879628" indent="0" algn="ctr">
              <a:buNone/>
              <a:defRPr sz="126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848550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168991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52009" y="402483"/>
            <a:ext cx="1552352" cy="6406475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4953" y="402483"/>
            <a:ext cx="4567064" cy="6406475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88363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129459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1204" y="1884671"/>
            <a:ext cx="6209407" cy="3144614"/>
          </a:xfrm>
        </p:spPr>
        <p:txBody>
          <a:bodyPr anchor="b"/>
          <a:lstStyle>
            <a:lvl1pPr>
              <a:defRPr sz="4724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1204" y="5059035"/>
            <a:ext cx="6209407" cy="1653678"/>
          </a:xfrm>
        </p:spPr>
        <p:txBody>
          <a:bodyPr/>
          <a:lstStyle>
            <a:lvl1pPr marL="0" indent="0">
              <a:buNone/>
              <a:defRPr sz="1890">
                <a:solidFill>
                  <a:schemeClr val="tx1"/>
                </a:solidFill>
              </a:defRPr>
            </a:lvl1pPr>
            <a:lvl2pPr marL="35995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2pPr>
            <a:lvl3pPr marL="719907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3pPr>
            <a:lvl4pPr marL="107986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4pPr>
            <a:lvl5pPr marL="1439814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5pPr>
            <a:lvl6pPr marL="179976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6pPr>
            <a:lvl7pPr marL="215972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7pPr>
            <a:lvl8pPr marL="251967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8pPr>
            <a:lvl9pPr marL="287962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032219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4953" y="2012414"/>
            <a:ext cx="3059708" cy="479654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4652" y="2012414"/>
            <a:ext cx="3059708" cy="479654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481464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402484"/>
            <a:ext cx="6209407" cy="1461188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891" y="1853171"/>
            <a:ext cx="3045646" cy="908210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891" y="2761381"/>
            <a:ext cx="3045646" cy="406157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4652" y="1853171"/>
            <a:ext cx="3060646" cy="908210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4652" y="2761381"/>
            <a:ext cx="3060646" cy="406157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085992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008153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240927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503978"/>
            <a:ext cx="2321966" cy="1763924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60646" y="1088455"/>
            <a:ext cx="3644652" cy="5372269"/>
          </a:xfrm>
        </p:spPr>
        <p:txBody>
          <a:bodyPr/>
          <a:lstStyle>
            <a:lvl1pPr>
              <a:defRPr sz="2519"/>
            </a:lvl1pPr>
            <a:lvl2pPr>
              <a:defRPr sz="2204"/>
            </a:lvl2pPr>
            <a:lvl3pPr>
              <a:defRPr sz="1890"/>
            </a:lvl3pPr>
            <a:lvl4pPr>
              <a:defRPr sz="1575"/>
            </a:lvl4pPr>
            <a:lvl5pPr>
              <a:defRPr sz="1575"/>
            </a:lvl5pPr>
            <a:lvl6pPr>
              <a:defRPr sz="1575"/>
            </a:lvl6pPr>
            <a:lvl7pPr>
              <a:defRPr sz="1575"/>
            </a:lvl7pPr>
            <a:lvl8pPr>
              <a:defRPr sz="1575"/>
            </a:lvl8pPr>
            <a:lvl9pPr>
              <a:defRPr sz="1575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2267902"/>
            <a:ext cx="2321966" cy="4201570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02591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503978"/>
            <a:ext cx="2321966" cy="1763924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60646" y="1088455"/>
            <a:ext cx="3644652" cy="5372269"/>
          </a:xfrm>
        </p:spPr>
        <p:txBody>
          <a:bodyPr anchor="t"/>
          <a:lstStyle>
            <a:lvl1pPr marL="0" indent="0">
              <a:buNone/>
              <a:defRPr sz="2519"/>
            </a:lvl1pPr>
            <a:lvl2pPr marL="359954" indent="0">
              <a:buNone/>
              <a:defRPr sz="2204"/>
            </a:lvl2pPr>
            <a:lvl3pPr marL="719907" indent="0">
              <a:buNone/>
              <a:defRPr sz="1890"/>
            </a:lvl3pPr>
            <a:lvl4pPr marL="1079861" indent="0">
              <a:buNone/>
              <a:defRPr sz="1575"/>
            </a:lvl4pPr>
            <a:lvl5pPr marL="1439814" indent="0">
              <a:buNone/>
              <a:defRPr sz="1575"/>
            </a:lvl5pPr>
            <a:lvl6pPr marL="1799768" indent="0">
              <a:buNone/>
              <a:defRPr sz="1575"/>
            </a:lvl6pPr>
            <a:lvl7pPr marL="2159721" indent="0">
              <a:buNone/>
              <a:defRPr sz="1575"/>
            </a:lvl7pPr>
            <a:lvl8pPr marL="2519675" indent="0">
              <a:buNone/>
              <a:defRPr sz="1575"/>
            </a:lvl8pPr>
            <a:lvl9pPr marL="2879628" indent="0">
              <a:buNone/>
              <a:defRPr sz="1575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2267902"/>
            <a:ext cx="2321966" cy="4201570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516632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4953" y="402484"/>
            <a:ext cx="6209407" cy="1461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953" y="2012414"/>
            <a:ext cx="6209407" cy="47965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4953" y="7006700"/>
            <a:ext cx="1619845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84773" y="7006700"/>
            <a:ext cx="2429768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84515" y="7006700"/>
            <a:ext cx="1619845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057410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719907" rtl="0" eaLnBrk="1" latinLnBrk="0" hangingPunct="1">
        <a:lnSpc>
          <a:spcPct val="90000"/>
        </a:lnSpc>
        <a:spcBef>
          <a:spcPct val="0"/>
        </a:spcBef>
        <a:buNone/>
        <a:defRPr sz="346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9977" indent="-179977" algn="l" defTabSz="71990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204" kern="1200">
          <a:solidFill>
            <a:schemeClr val="tx1"/>
          </a:solidFill>
          <a:latin typeface="+mn-lt"/>
          <a:ea typeface="+mn-ea"/>
          <a:cs typeface="+mn-cs"/>
        </a:defRPr>
      </a:lvl1pPr>
      <a:lvl2pPr marL="539930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899884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3pPr>
      <a:lvl4pPr marL="1259837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619791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97974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339698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699652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305960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1pPr>
      <a:lvl2pPr marL="35995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719907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07986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43981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79976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15972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519675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287962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le 4">
            <a:extLst>
              <a:ext uri="{FF2B5EF4-FFF2-40B4-BE49-F238E27FC236}">
                <a16:creationId xmlns:a16="http://schemas.microsoft.com/office/drawing/2014/main" id="{BB1788F9-F6EB-7AB3-0E56-38F1E2B8C3B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37279607"/>
              </p:ext>
            </p:extLst>
          </p:nvPr>
        </p:nvGraphicFramePr>
        <p:xfrm>
          <a:off x="300941" y="862921"/>
          <a:ext cx="6632294" cy="6390879"/>
        </p:xfrm>
        <a:graphic>
          <a:graphicData uri="http://schemas.openxmlformats.org/drawingml/2006/table">
            <a:tbl>
              <a:tblPr firstRow="1" firstCol="1" bandRow="1"/>
              <a:tblGrid>
                <a:gridCol w="1472759">
                  <a:extLst>
                    <a:ext uri="{9D8B030D-6E8A-4147-A177-3AD203B41FA5}">
                      <a16:colId xmlns:a16="http://schemas.microsoft.com/office/drawing/2014/main" val="1262243040"/>
                    </a:ext>
                  </a:extLst>
                </a:gridCol>
                <a:gridCol w="1472759">
                  <a:extLst>
                    <a:ext uri="{9D8B030D-6E8A-4147-A177-3AD203B41FA5}">
                      <a16:colId xmlns:a16="http://schemas.microsoft.com/office/drawing/2014/main" val="711517272"/>
                    </a:ext>
                  </a:extLst>
                </a:gridCol>
                <a:gridCol w="1102131">
                  <a:extLst>
                    <a:ext uri="{9D8B030D-6E8A-4147-A177-3AD203B41FA5}">
                      <a16:colId xmlns:a16="http://schemas.microsoft.com/office/drawing/2014/main" val="1866988618"/>
                    </a:ext>
                  </a:extLst>
                </a:gridCol>
                <a:gridCol w="1102131">
                  <a:extLst>
                    <a:ext uri="{9D8B030D-6E8A-4147-A177-3AD203B41FA5}">
                      <a16:colId xmlns:a16="http://schemas.microsoft.com/office/drawing/2014/main" val="2316603490"/>
                    </a:ext>
                  </a:extLst>
                </a:gridCol>
                <a:gridCol w="741257">
                  <a:extLst>
                    <a:ext uri="{9D8B030D-6E8A-4147-A177-3AD203B41FA5}">
                      <a16:colId xmlns:a16="http://schemas.microsoft.com/office/drawing/2014/main" val="3410515536"/>
                    </a:ext>
                  </a:extLst>
                </a:gridCol>
                <a:gridCol w="741257">
                  <a:extLst>
                    <a:ext uri="{9D8B030D-6E8A-4147-A177-3AD203B41FA5}">
                      <a16:colId xmlns:a16="http://schemas.microsoft.com/office/drawing/2014/main" val="2298898232"/>
                    </a:ext>
                  </a:extLst>
                </a:gridCol>
              </a:tblGrid>
              <a:tr h="21610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 (n=10)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R (n=6)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de-DE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8508516"/>
                  </a:ext>
                </a:extLst>
              </a:tr>
              <a:tr h="2310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an ± SD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an ± SD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de-DE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hens d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6868880"/>
                  </a:ext>
                </a:extLst>
              </a:tr>
              <a:tr h="253361">
                <a:tc rowSpan="15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haracteristics</a:t>
                      </a: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at T0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de-DE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ge, years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7.4 ± 6.5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0.2 ± 8.1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807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73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22427"/>
                  </a:ext>
                </a:extLst>
              </a:tr>
              <a:tr h="253361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de-DE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ender, male / female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1 / 6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 / 6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de-DE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5059340"/>
                  </a:ext>
                </a:extLst>
              </a:tr>
              <a:tr h="253361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de-DE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eight, cm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7.7 ± 8.4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6.3 ± 9.4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673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56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4932921"/>
                  </a:ext>
                </a:extLst>
              </a:tr>
              <a:tr h="253361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de-DE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eight, kg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7.6 ± 12.7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1.8 ± 18.2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652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9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36657364"/>
                  </a:ext>
                </a:extLst>
              </a:tr>
              <a:tr h="253361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de-DE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MI, kg/m</a:t>
                      </a:r>
                      <a:r>
                        <a:rPr lang="de-DE" sz="1000" b="1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7.7 ± 3.8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6.2 ± 5.9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336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24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3674728"/>
                  </a:ext>
                </a:extLst>
              </a:tr>
              <a:tr h="369831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de-DE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isease duration, years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.8 ± 6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 ± 6.7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158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0.192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0964270"/>
                  </a:ext>
                </a:extLst>
              </a:tr>
              <a:tr h="253361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de-DE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EDD, mg/d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64.8 ± 426.8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68.4 ± 337.4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610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0.764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38753580"/>
                  </a:ext>
                </a:extLst>
              </a:tr>
              <a:tr h="253361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de-DE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Ca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5.9 ± 3.1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6.2 ± 1.9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421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0.109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2150986"/>
                  </a:ext>
                </a:extLst>
              </a:tr>
              <a:tr h="253361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de-DE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oehn&amp; Yahr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.1 ± 0.6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7 ± 0.6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630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13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04689125"/>
                  </a:ext>
                </a:extLst>
              </a:tr>
              <a:tr h="253361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de-DE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UPDRS-III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.2 ± 10.2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.5 ± 5.8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810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57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4951730"/>
                  </a:ext>
                </a:extLst>
              </a:tr>
              <a:tr h="253361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de-DE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UG, s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.0 ± 2.9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.8 ± 1.0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448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35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6559374"/>
                  </a:ext>
                </a:extLst>
              </a:tr>
              <a:tr h="253361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de-DE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MWT distance, m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66.5 ± 24.6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91.0 ± 18.0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533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.091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8054340"/>
                  </a:ext>
                </a:extLst>
              </a:tr>
              <a:tr h="253361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de-DE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-ADL, surface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9.1 ± 43.8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9.7 ± 20.9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295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21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25573052"/>
                  </a:ext>
                </a:extLst>
              </a:tr>
              <a:tr h="253361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de-DE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DQ-39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.6 ± 9.9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9.0 ± 19.8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168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0.66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7912311"/>
                  </a:ext>
                </a:extLst>
              </a:tr>
              <a:tr h="253361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de-DE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DQ-Mobility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.3 ± 20.7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3.2 ± 22.9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058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0.274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129582"/>
                  </a:ext>
                </a:extLst>
              </a:tr>
              <a:tr h="253361">
                <a:tc rowSpan="5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hanges T0 to T2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de-DE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Δ UPDRS-III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2.1 ± 1.9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.0 ± 2.1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52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.546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4386555"/>
                  </a:ext>
                </a:extLst>
              </a:tr>
              <a:tr h="253361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de-DE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Δ TUG (s)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 ± 0.6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8 ± 0.8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78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980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0331747"/>
                  </a:ext>
                </a:extLst>
              </a:tr>
              <a:tr h="253361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de-DE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Δ 2MWT (m)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 ± 5.7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4.3 ± 20.1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89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635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6735450"/>
                  </a:ext>
                </a:extLst>
              </a:tr>
              <a:tr h="253361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de-DE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Δ PDQ-Mobility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6 ± 2.1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.0 ± 2.6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17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016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4438273"/>
                  </a:ext>
                </a:extLst>
              </a:tr>
              <a:tr h="253361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de-DE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Δ FES-I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2.1 ± 2.2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 ± 0.1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28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862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3974913"/>
                  </a:ext>
                </a:extLst>
              </a:tr>
              <a:tr h="253361">
                <a:tc row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ssessed at T2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de-DE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ersonal added value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.4 ± 1.3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.8 ± 1.3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353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61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01258200"/>
                  </a:ext>
                </a:extLst>
              </a:tr>
              <a:tr h="253361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de-DE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US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0.3 ± 25.1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8.8 ± 8.5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391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53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26661624"/>
                  </a:ext>
                </a:extLst>
              </a:tr>
              <a:tr h="253361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de-DE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F, % (R: n=9)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7.3 ± 19.3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6.7 ± 8.7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304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08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596" marR="425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4009756"/>
                  </a:ext>
                </a:extLst>
              </a:tr>
            </a:tbl>
          </a:graphicData>
        </a:graphic>
      </p:graphicFrame>
      <p:sp>
        <p:nvSpPr>
          <p:cNvPr id="9" name="Textfeld 8">
            <a:extLst>
              <a:ext uri="{FF2B5EF4-FFF2-40B4-BE49-F238E27FC236}">
                <a16:creationId xmlns:a16="http://schemas.microsoft.com/office/drawing/2014/main" id="{199C3F21-AABA-BD62-5415-8DEC4191449A}"/>
              </a:ext>
            </a:extLst>
          </p:cNvPr>
          <p:cNvSpPr txBox="1"/>
          <p:nvPr/>
        </p:nvSpPr>
        <p:spPr>
          <a:xfrm>
            <a:off x="300941" y="305875"/>
            <a:ext cx="6694607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S1: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Characteristics of R and NR according to baseline examinations and outcome changes from T0 to T2</a:t>
            </a:r>
            <a:endParaRPr lang="de-DE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838695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322</Words>
  <Application>Microsoft Office PowerPoint</Application>
  <PresentationFormat>Benutzerdefiniert</PresentationFormat>
  <Paragraphs>129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ützow, Lisa</dc:creator>
  <cp:lastModifiedBy>Lützow, Lisa</cp:lastModifiedBy>
  <cp:revision>1</cp:revision>
  <dcterms:created xsi:type="dcterms:W3CDTF">2023-02-16T07:37:04Z</dcterms:created>
  <dcterms:modified xsi:type="dcterms:W3CDTF">2023-02-16T07:41:25Z</dcterms:modified>
</cp:coreProperties>
</file>